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firstSlideNum="34" saveSubsetFonts="1" autoCompressPictures="0">
  <p:sldMasterIdLst>
    <p:sldMasterId id="2147483660" r:id="rId1"/>
  </p:sldMasterIdLst>
  <p:notesMasterIdLst>
    <p:notesMasterId r:id="rId3"/>
  </p:notes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000"/>
    <p:restoredTop sz="94658"/>
  </p:normalViewPr>
  <p:slideViewPr>
    <p:cSldViewPr snapToGrid="0" snapToObjects="1">
      <p:cViewPr varScale="1">
        <p:scale>
          <a:sx n="92" d="100"/>
          <a:sy n="92" d="100"/>
        </p:scale>
        <p:origin x="3264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B086586-3BAA-4242-9698-3EF19BE90524}" type="datetimeFigureOut">
              <a:rPr lang="en-US" smtClean="0"/>
              <a:t>6/11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FC40E42-5407-2B48-A799-41DCCDC75A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88470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9ED9CBF-5974-974C-B24A-81489DDD41B4}" type="slidenum">
              <a:rPr lang="en-US" smtClean="0"/>
              <a:t>3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626050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D097FC-4293-3144-BF6F-45322FC44BA5}" type="datetime1">
              <a:rPr lang="en-NZ" smtClean="0"/>
              <a:t>11/0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D11345-D287-1041-8606-7887A9C707A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CE5BB-5EFE-974C-A55F-EDFB8FF804C9}" type="datetime1">
              <a:rPr lang="en-NZ" smtClean="0"/>
              <a:t>11/0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D11345-D287-1041-8606-7887A9C707A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4C37B-35FA-C14E-A872-CF35B004F7D0}" type="datetime1">
              <a:rPr lang="en-NZ" smtClean="0"/>
              <a:t>11/0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D11345-D287-1041-8606-7887A9C707A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6AA37D-0D7E-A349-8015-F7E1785F74F7}" type="datetime1">
              <a:rPr lang="en-NZ" smtClean="0"/>
              <a:t>11/0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D11345-D287-1041-8606-7887A9C707A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CC51F-FB68-A944-AF44-1551479AC68D}" type="datetime1">
              <a:rPr lang="en-NZ" smtClean="0"/>
              <a:t>11/0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D11345-D287-1041-8606-7887A9C707A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CD4495-F860-F445-A5C2-B84D4B3916F0}" type="datetime1">
              <a:rPr lang="en-NZ" smtClean="0"/>
              <a:t>11/06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D11345-D287-1041-8606-7887A9C707A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94B9FC-C9DB-C745-AD72-7A257AF2651C}" type="datetime1">
              <a:rPr lang="en-NZ" smtClean="0"/>
              <a:t>11/06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D11345-D287-1041-8606-7887A9C707A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41444A-F572-5546-A8A6-3A51B0AB4301}" type="datetime1">
              <a:rPr lang="en-NZ" smtClean="0"/>
              <a:t>11/06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D11345-D287-1041-8606-7887A9C707A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2D41C-1A48-3446-96F0-DFEB3B09C7E5}" type="datetime1">
              <a:rPr lang="en-NZ" smtClean="0"/>
              <a:t>11/06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D11345-D287-1041-8606-7887A9C707A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EC98-BAA4-2845-BB85-43E4A5CA8BC0}" type="datetime1">
              <a:rPr lang="en-NZ" smtClean="0"/>
              <a:t>11/06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D11345-D287-1041-8606-7887A9C707A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0F6C60-81D5-3841-B0C0-3881122A11FF}" type="datetime1">
              <a:rPr lang="en-NZ" smtClean="0"/>
              <a:t>11/06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D11345-D287-1041-8606-7887A9C707A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876406-2C1B-8042-80E5-2B7FC8AC2AFB}" type="datetime1">
              <a:rPr lang="en-NZ" smtClean="0"/>
              <a:t>11/0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D11345-D287-1041-8606-7887A9C707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30565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1985" y="5142943"/>
            <a:ext cx="5313482" cy="1480748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94362" y="473843"/>
            <a:ext cx="5082746" cy="1539041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28460" y="1983406"/>
            <a:ext cx="5173361" cy="1510549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95508" y="3546487"/>
            <a:ext cx="5201788" cy="1536728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90727" y="6743963"/>
            <a:ext cx="1452160" cy="1128581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645166" y="6760437"/>
            <a:ext cx="1458260" cy="1103869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435486" y="6758649"/>
            <a:ext cx="1499286" cy="1078941"/>
          </a:xfrm>
          <a:prstGeom prst="rect">
            <a:avLst/>
          </a:prstGeom>
        </p:spPr>
      </p:pic>
      <p:sp>
        <p:nvSpPr>
          <p:cNvPr id="23" name="TextBox 22"/>
          <p:cNvSpPr txBox="1"/>
          <p:nvPr/>
        </p:nvSpPr>
        <p:spPr>
          <a:xfrm>
            <a:off x="367879" y="408668"/>
            <a:ext cx="3385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(a)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367879" y="1893243"/>
            <a:ext cx="34496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(b)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367879" y="3487266"/>
            <a:ext cx="33054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/>
              <a:t>(c)</a:t>
            </a:r>
            <a:endParaRPr lang="en-US" sz="1100" b="1" dirty="0"/>
          </a:p>
        </p:txBody>
      </p:sp>
      <p:sp>
        <p:nvSpPr>
          <p:cNvPr id="26" name="TextBox 25"/>
          <p:cNvSpPr txBox="1"/>
          <p:nvPr/>
        </p:nvSpPr>
        <p:spPr>
          <a:xfrm>
            <a:off x="367879" y="5040094"/>
            <a:ext cx="34496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/>
              <a:t>(d)</a:t>
            </a:r>
            <a:endParaRPr lang="en-US" sz="1100" b="1" dirty="0"/>
          </a:p>
        </p:txBody>
      </p:sp>
      <p:sp>
        <p:nvSpPr>
          <p:cNvPr id="27" name="TextBox 26"/>
          <p:cNvSpPr txBox="1"/>
          <p:nvPr/>
        </p:nvSpPr>
        <p:spPr>
          <a:xfrm>
            <a:off x="367879" y="6655532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(e)</a:t>
            </a:r>
          </a:p>
        </p:txBody>
      </p:sp>
      <p:sp>
        <p:nvSpPr>
          <p:cNvPr id="15" name="Rectangle 14"/>
          <p:cNvSpPr/>
          <p:nvPr/>
        </p:nvSpPr>
        <p:spPr>
          <a:xfrm>
            <a:off x="261002" y="7827251"/>
            <a:ext cx="6118412" cy="186974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sz="1100" b="1" dirty="0">
                <a:effectLst/>
                <a:latin typeface="Arial" charset="0"/>
                <a:ea typeface="Droid Sans Fallback" charset="0"/>
                <a:cs typeface="FreeSans" charset="0"/>
              </a:rPr>
              <a:t>Supplementary Figure 1. </a:t>
            </a:r>
            <a:r>
              <a:rPr lang="en-NZ" sz="1100" dirty="0">
                <a:effectLst/>
                <a:latin typeface="Arial" charset="0"/>
                <a:ea typeface="Droid Sans Fallback" charset="0"/>
                <a:cs typeface="FreeSans" charset="0"/>
              </a:rPr>
              <a:t>Density distributions of the </a:t>
            </a:r>
            <a:r>
              <a:rPr lang="en-NZ" sz="1100" i="1" dirty="0">
                <a:effectLst/>
                <a:latin typeface="Arial" charset="0"/>
                <a:ea typeface="Droid Sans Fallback" charset="0"/>
                <a:cs typeface="FreeSans" charset="0"/>
              </a:rPr>
              <a:t>CDH1</a:t>
            </a:r>
            <a:r>
              <a:rPr lang="en-NZ" sz="1100" i="1" baseline="30000" dirty="0">
                <a:effectLst/>
                <a:latin typeface="Arial" charset="0"/>
                <a:ea typeface="Droid Sans Fallback" charset="0"/>
                <a:cs typeface="FreeSans" charset="0"/>
              </a:rPr>
              <a:t>-/- </a:t>
            </a:r>
            <a:r>
              <a:rPr lang="en-NZ" sz="1100" dirty="0">
                <a:effectLst/>
                <a:latin typeface="Arial" charset="0"/>
                <a:ea typeface="Droid Sans Fallback" charset="0"/>
                <a:cs typeface="FreeSans" charset="0"/>
              </a:rPr>
              <a:t>/ MCF10A viability ratios for major cell signalling pathways that overlap with the PI3K/AKT pathway.  Each pathway is represented by three plots: (</a:t>
            </a:r>
            <a:r>
              <a:rPr lang="en-NZ" sz="1100" dirty="0" err="1">
                <a:effectLst/>
                <a:latin typeface="Arial" charset="0"/>
                <a:ea typeface="Droid Sans Fallback" charset="0"/>
                <a:cs typeface="FreeSans" charset="0"/>
              </a:rPr>
              <a:t>i</a:t>
            </a:r>
            <a:r>
              <a:rPr lang="en-NZ" sz="1100" dirty="0">
                <a:effectLst/>
                <a:latin typeface="Arial" charset="0"/>
                <a:ea typeface="Droid Sans Fallback" charset="0"/>
                <a:cs typeface="FreeSans" charset="0"/>
              </a:rPr>
              <a:t>) the complete pathway (excluding genes encoding extracellular ligands); (ii) the pathway minus genes that overlap with the PI3K/AKT pathway and (iii) the overlapping genes. </a:t>
            </a:r>
            <a:r>
              <a:rPr lang="en-NZ" sz="1100" b="1" dirty="0">
                <a:effectLst/>
                <a:latin typeface="Arial" charset="0"/>
                <a:ea typeface="Droid Sans Fallback" charset="0"/>
                <a:cs typeface="FreeSans" charset="0"/>
              </a:rPr>
              <a:t>(a)</a:t>
            </a:r>
            <a:r>
              <a:rPr lang="en-NZ" sz="1100" dirty="0">
                <a:effectLst/>
                <a:latin typeface="Arial" charset="0"/>
                <a:ea typeface="Droid Sans Fallback" charset="0"/>
                <a:cs typeface="FreeSans" charset="0"/>
              </a:rPr>
              <a:t> MTOR pathway; </a:t>
            </a:r>
            <a:r>
              <a:rPr lang="en-NZ" sz="1100" b="1" dirty="0">
                <a:effectLst/>
                <a:latin typeface="Arial" charset="0"/>
                <a:ea typeface="Droid Sans Fallback" charset="0"/>
                <a:cs typeface="FreeSans" charset="0"/>
              </a:rPr>
              <a:t>(b)</a:t>
            </a:r>
            <a:r>
              <a:rPr lang="en-NZ" sz="1100" dirty="0">
                <a:effectLst/>
                <a:latin typeface="Arial" charset="0"/>
                <a:ea typeface="Droid Sans Fallback" charset="0"/>
                <a:cs typeface="FreeSans" charset="0"/>
              </a:rPr>
              <a:t> RAS pathway; </a:t>
            </a:r>
            <a:r>
              <a:rPr lang="en-NZ" sz="1100" b="1" dirty="0">
                <a:effectLst/>
                <a:latin typeface="Arial" charset="0"/>
                <a:ea typeface="Droid Sans Fallback" charset="0"/>
                <a:cs typeface="FreeSans" charset="0"/>
              </a:rPr>
              <a:t>(c)</a:t>
            </a:r>
            <a:r>
              <a:rPr lang="en-NZ" sz="1100" dirty="0">
                <a:effectLst/>
                <a:latin typeface="Arial" charset="0"/>
                <a:ea typeface="Droid Sans Fallback" charset="0"/>
                <a:cs typeface="FreeSans" charset="0"/>
              </a:rPr>
              <a:t> TNF pathway; </a:t>
            </a:r>
            <a:r>
              <a:rPr lang="en-NZ" sz="1100" b="1" dirty="0">
                <a:effectLst/>
                <a:latin typeface="Arial" charset="0"/>
                <a:ea typeface="Droid Sans Fallback" charset="0"/>
                <a:cs typeface="FreeSans" charset="0"/>
              </a:rPr>
              <a:t>(d)</a:t>
            </a:r>
            <a:r>
              <a:rPr lang="en-NZ" sz="1100" dirty="0">
                <a:effectLst/>
                <a:latin typeface="Arial" charset="0"/>
                <a:ea typeface="Droid Sans Fallback" charset="0"/>
                <a:cs typeface="FreeSans" charset="0"/>
              </a:rPr>
              <a:t> JAK/STAT pathway, and </a:t>
            </a:r>
            <a:r>
              <a:rPr lang="en-NZ" sz="1100" b="1" dirty="0">
                <a:effectLst/>
                <a:latin typeface="Arial" charset="0"/>
                <a:ea typeface="Droid Sans Fallback" charset="0"/>
                <a:cs typeface="FreeSans" charset="0"/>
              </a:rPr>
              <a:t>(e) </a:t>
            </a:r>
            <a:r>
              <a:rPr lang="en-NZ" sz="1100" dirty="0">
                <a:effectLst/>
                <a:latin typeface="Arial" charset="0"/>
                <a:ea typeface="Droid Sans Fallback" charset="0"/>
                <a:cs typeface="FreeSans" charset="0"/>
              </a:rPr>
              <a:t>focal adhesion pathway. The statistical significance was determined using the </a:t>
            </a:r>
            <a:r>
              <a:rPr lang="en-AU" sz="1100" dirty="0">
                <a:effectLst/>
                <a:latin typeface="Arial" charset="0"/>
                <a:ea typeface="Droid Sans Fallback" charset="0"/>
                <a:cs typeface="FreeSans" charset="0"/>
              </a:rPr>
              <a:t>Kolmogorov-Smirnoff test.</a:t>
            </a:r>
            <a:endParaRPr lang="en-GB" sz="1100" dirty="0">
              <a:effectLst/>
              <a:latin typeface="Liberation Serif" charset="0"/>
              <a:ea typeface="Droid Sans Fallback" charset="0"/>
              <a:cs typeface="FreeSans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698667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0</TotalTime>
  <Words>132</Words>
  <Application>Microsoft Macintosh PowerPoint</Application>
  <PresentationFormat>A4 Paper (210x297 mm)</PresentationFormat>
  <Paragraphs>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Droid Sans Fallback</vt:lpstr>
      <vt:lpstr>FreeSans</vt:lpstr>
      <vt:lpstr>Liberation Serif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3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rry Guilford</dc:creator>
  <cp:lastModifiedBy>Microsoft Office User</cp:lastModifiedBy>
  <cp:revision>19</cp:revision>
  <cp:lastPrinted>2018-05-21T05:19:21Z</cp:lastPrinted>
  <dcterms:created xsi:type="dcterms:W3CDTF">2017-10-30T07:26:35Z</dcterms:created>
  <dcterms:modified xsi:type="dcterms:W3CDTF">2018-06-11T02:29:41Z</dcterms:modified>
</cp:coreProperties>
</file>